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  <p:sldId id="278" r:id="rId21"/>
    <p:sldId id="279" r:id="rId22"/>
    <p:sldId id="280" r:id="rId23"/>
    <p:sldId id="281" r:id="rId24"/>
    <p:sldId id="282" r:id="rId25"/>
    <p:sldId id="283" r:id="rId2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4" d="100"/>
          <a:sy n="54" d="100"/>
        </p:scale>
        <p:origin x="68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60FBA0-89F0-472B-BEF8-874CC00411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44E602-52F1-454F-8E20-E83B56547A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0CA132-1145-4647-8DCB-3ADFDE7D9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374B20-0FAE-4BF5-A939-D43EDD753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FDABFE-9C4A-4FA9-A412-574EBD0AB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05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6B484-B219-47F6-B3B3-947184E1C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DFF8A6-E60A-4A56-A400-56968CB639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D542D1-8CDA-49A5-9BC4-32B79C1DD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205A05-F859-4511-AC34-93AF64AED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714C33-F520-4EF8-99AE-EB7041139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403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FFDAF5-4D73-4281-A536-B718CE17D1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34DF8A-B47D-48D4-A252-9FFEBD6973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7F2CE9-A189-4694-A5E1-52765433F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DD9B6-0D1C-46FA-9AFE-F2718534D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DC5457-DA2D-4A2F-9284-DAA59B786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90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C336D-7418-4302-9F8C-AA7DBBBC7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92B98-43ED-4A9C-8BC1-5F3CD12318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EE212-53C3-4D98-8D05-ED6A59836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DCDE3-0CFC-4BB0-A2D4-E177DCB8C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A72B3-687A-4F12-8CDB-5BA8974B6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87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B6AF20-7D02-49FD-B75E-6223084E3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66C27B-CA52-4284-85A1-ED17622C37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24DEAD-84C9-4FEE-8A6B-EB708103F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45C8D-69F7-4682-85DF-57DEC082D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C2EA5-793B-4553-85F8-F42D44BE6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901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69A61-6152-4FC1-B2E5-5A4BDAB2CE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B2398F-EEE9-4B4D-91FD-24D0453490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226563-0E13-4B0F-9AE5-7D930A59A7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ECFDB1-BD5A-4396-A154-1D7CC4742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C6A328-93BC-429E-9EE3-9D8424F16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C3210E-5B9D-46FD-8EC6-044924AF5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48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B0F48F-F839-4112-95E6-8226897D3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E30D4E-7657-4B06-9FEF-1316A3AAFF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E7DCE1-0F31-4590-8A1D-152669264F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AD4FBE-36BD-4B9F-987A-003840C238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6D66B1-416F-485F-9491-0CCEBE6FAB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66EC0B-762B-406C-A3DD-A41DF9531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46C6FC-231A-4A11-AB33-91E079453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1BFB59-FC5D-4B29-829B-3D6697C20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66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73886-0EA5-4534-A2A1-CE6D1EEF03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18F0EC-21C1-482E-B5DE-D96475FA6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4628CA-0869-43CD-B9FA-37651D4EA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EDBF56-6080-4D13-89A6-A0A0AA96B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259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2390EA-35D3-448F-ACA4-89F9E5FEA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9897F7-23BA-4FCC-AC98-E8B709815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45865A-5211-4267-BE91-DEEB0FEDF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340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F17F5-EF83-4685-8A3E-E5860F2BD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FEF90C-09BF-470E-B4F7-B4EC6B09E4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90F965-5D2D-41D2-94D1-452D4C54F1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3F6F39-4436-4934-8294-F8C67A5D8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8A2CF4-4DE4-45F8-B7E0-25584D034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846098-BC2A-4EE1-BBE3-0C5BD5200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829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47C57-1704-46CE-9249-A7824BC094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E61603-D048-477A-8CF8-DFD7252673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A661BE-E698-4241-A17C-DF79707B27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C0E772-8408-4FC9-B4E3-DB5FBADAE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43A3C1-DDFE-4548-8738-1DF002B4F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80122E-9416-4F48-960D-B5BDAC152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333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9BA2AA-B666-4914-BEBC-806387CC1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801038-DC05-4F70-BE74-B3D439C25B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E1F3B3-C5AF-47D8-8E9F-B52FE69DED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25005-F80B-412C-BB4E-FF9585B7F841}" type="datetimeFigureOut">
              <a:rPr lang="en-US" smtClean="0"/>
              <a:t>6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C33953-FC05-48B3-8C55-619DA707D0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269F26-2414-443F-AE9D-16F88DEC47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7E8BE-EF5E-48E3-BFC9-09244B39A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52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4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4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4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4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4224C3-6BE7-4D29-8718-3284A064305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econdary lab outcom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074791-C8EB-4040-8A50-5530F0641DC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9821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442654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7. Forest plot – Lambda Free Light Chain (FLC) reduction ratio (%) - R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146B7B7-1F1F-4BF5-8541-C242E2C91903}"/>
              </a:ext>
              <a:ext uri="{147F2762-F138-4A5C-976F-8EAC2B608ADB}">
                <a16:predDERef xmlns:a16="http://schemas.microsoft.com/office/drawing/2014/main" pred="{DA3ADCE2-9C8A-4616-AE94-F7B34B7E00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4604" y="587105"/>
            <a:ext cx="10749013" cy="3558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98338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2602331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8a. Forest plot – Lambda Free Light Chain (FLC) removal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5274B20-3136-47B9-A698-D5A8881BC277}"/>
              </a:ext>
              <a:ext uri="{147F2762-F138-4A5C-976F-8EAC2B608ADB}">
                <a16:predDERef xmlns:a16="http://schemas.microsoft.com/office/drawing/2014/main" pred="{D3D01C6B-8330-4E07-AC6C-2E8642DCB5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094" y="161188"/>
            <a:ext cx="8275572" cy="2532583"/>
          </a:xfrm>
          <a:prstGeom prst="rect">
            <a:avLst/>
          </a:prstGeom>
        </p:spPr>
      </p:pic>
      <p:sp>
        <p:nvSpPr>
          <p:cNvPr id="6" name="Title 3">
            <a:extLst>
              <a:ext uri="{FF2B5EF4-FFF2-40B4-BE49-F238E27FC236}">
                <a16:creationId xmlns:a16="http://schemas.microsoft.com/office/drawing/2014/main" id="{F201D41B-08CA-4ADB-A1BF-1A4EF02DCD62}"/>
              </a:ext>
            </a:extLst>
          </p:cNvPr>
          <p:cNvSpPr txBox="1">
            <a:spLocks/>
          </p:cNvSpPr>
          <p:nvPr/>
        </p:nvSpPr>
        <p:spPr>
          <a:xfrm>
            <a:off x="177870" y="62248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8b. Forest plot – Lambda Free Light Chain (FLC) removal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3D01C6B-8330-4E07-AC6C-2E8642DCB50D}"/>
              </a:ext>
              <a:ext uri="{147F2762-F138-4A5C-976F-8EAC2B608ADB}">
                <a16:predDERef xmlns:a16="http://schemas.microsoft.com/office/drawing/2014/main" pred="{B4E38043-00F0-4F0D-A439-6454AD5DA1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888" y="3470508"/>
            <a:ext cx="8533504" cy="2680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11192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9. Forest plot – </a:t>
            </a:r>
            <a:r>
              <a:rPr lang="en-US" sz="2000" dirty="0" err="1"/>
              <a:t>Predialysis</a:t>
            </a:r>
            <a:r>
              <a:rPr lang="en-US" sz="2000" dirty="0"/>
              <a:t> Lambda Free Light Chain (FLC) 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9AAA382-CC6C-EA4A-9040-1BF9878FE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634" y="477520"/>
            <a:ext cx="8570654" cy="4653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94302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0. Forest plot – Kappa Free Light Chain (FLC) reduction ratio (%) - N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CF4A799-4619-C943-8BE8-C9E04F351D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8404" y="223520"/>
            <a:ext cx="8867721" cy="4961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63368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2602331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1a. Forest plot – Kappa Free Light Chain (FLC) removal- RS.</a:t>
            </a:r>
          </a:p>
        </p:txBody>
      </p:sp>
      <p:sp>
        <p:nvSpPr>
          <p:cNvPr id="6" name="Title 3">
            <a:extLst>
              <a:ext uri="{FF2B5EF4-FFF2-40B4-BE49-F238E27FC236}">
                <a16:creationId xmlns:a16="http://schemas.microsoft.com/office/drawing/2014/main" id="{F201D41B-08CA-4ADB-A1BF-1A4EF02DCD62}"/>
              </a:ext>
            </a:extLst>
          </p:cNvPr>
          <p:cNvSpPr txBox="1">
            <a:spLocks/>
          </p:cNvSpPr>
          <p:nvPr/>
        </p:nvSpPr>
        <p:spPr>
          <a:xfrm>
            <a:off x="177870" y="62248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1b. Forest plot – Kappa Free Light Chain (FLC) removal- NRS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0682549-04A0-463C-B8E2-88507A33AEE9}"/>
              </a:ext>
              <a:ext uri="{147F2762-F138-4A5C-976F-8EAC2B608ADB}">
                <a16:predDERef xmlns:a16="http://schemas.microsoft.com/office/drawing/2014/main" pred="{7093BAD4-435C-4E69-BF69-F66D9C60A9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70" y="350171"/>
            <a:ext cx="8304404" cy="235781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093BAD4-435C-4E69-BF69-F66D9C60A9A0}"/>
              </a:ext>
              <a:ext uri="{147F2762-F138-4A5C-976F-8EAC2B608ADB}">
                <a16:predDERef xmlns:a16="http://schemas.microsoft.com/office/drawing/2014/main" pred="{B34F7BD5-634D-4243-B00D-728CC8B4DB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920" y="3187548"/>
            <a:ext cx="8568400" cy="2649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59897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2. Forest plot – </a:t>
            </a:r>
            <a:r>
              <a:rPr lang="en-US" sz="2000" dirty="0" err="1"/>
              <a:t>Predialysis</a:t>
            </a:r>
            <a:r>
              <a:rPr lang="en-US" sz="2000" dirty="0"/>
              <a:t> Kappa Free Light Chain (FLC) - NR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0D990D5-943F-4985-BA78-CA393698BF40}"/>
              </a:ext>
              <a:ext uri="{147F2762-F138-4A5C-976F-8EAC2B608ADB}">
                <a16:predDERef xmlns:a16="http://schemas.microsoft.com/office/drawing/2014/main" pred="{808BCFB6-E551-4D9B-B496-DBE531E581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131" y="1412240"/>
            <a:ext cx="9957394" cy="3521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81533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3. Forest plot – Myoglobin reduction ratio (%) - NR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FC50570-778E-48B2-BA6F-9B658AECAB7C}"/>
              </a:ext>
              <a:ext uri="{147F2762-F138-4A5C-976F-8EAC2B608ADB}">
                <a16:predDERef xmlns:a16="http://schemas.microsoft.com/office/drawing/2014/main" pred="{B8298CFC-1FEF-456F-8536-3CF5954B03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3310" y="460953"/>
            <a:ext cx="9896712" cy="39891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45744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289630" y="3211931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4a. Forest plot – Myoglobin removal- RS.</a:t>
            </a:r>
          </a:p>
        </p:txBody>
      </p:sp>
      <p:sp>
        <p:nvSpPr>
          <p:cNvPr id="6" name="Title 3">
            <a:extLst>
              <a:ext uri="{FF2B5EF4-FFF2-40B4-BE49-F238E27FC236}">
                <a16:creationId xmlns:a16="http://schemas.microsoft.com/office/drawing/2014/main" id="{F201D41B-08CA-4ADB-A1BF-1A4EF02DCD62}"/>
              </a:ext>
            </a:extLst>
          </p:cNvPr>
          <p:cNvSpPr txBox="1">
            <a:spLocks/>
          </p:cNvSpPr>
          <p:nvPr/>
        </p:nvSpPr>
        <p:spPr>
          <a:xfrm>
            <a:off x="177870" y="62248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4b. Forest plot – Myoglobin removal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82507E3-94F0-094D-89EB-E83F54ECF1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4458" y="70091"/>
            <a:ext cx="7291622" cy="32843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81D4CAC-DF18-4EBB-8681-BF5E69404E50}"/>
              </a:ext>
              <a:ext uri="{147F2762-F138-4A5C-976F-8EAC2B608ADB}">
                <a16:predDERef xmlns:a16="http://schemas.microsoft.com/office/drawing/2014/main" pred="{5DB2D244-4851-4C22-A209-812CD68E84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810" y="3797148"/>
            <a:ext cx="7454270" cy="2258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67178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262822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5a. Forest plot – </a:t>
            </a:r>
            <a:r>
              <a:rPr lang="en-US" sz="2000" dirty="0" err="1"/>
              <a:t>Predialysis</a:t>
            </a:r>
            <a:r>
              <a:rPr lang="en-US" sz="2000" dirty="0"/>
              <a:t> Myoglobin 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A57FD19-398F-41E1-A174-E61816B5BB71}"/>
              </a:ext>
              <a:ext uri="{147F2762-F138-4A5C-976F-8EAC2B608ADB}">
                <a16:predDERef xmlns:a16="http://schemas.microsoft.com/office/drawing/2014/main" pred="{0C784C3E-3141-4B98-BCB7-5B5B306B0B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151" y="202578"/>
            <a:ext cx="8283727" cy="2425651"/>
          </a:xfrm>
          <a:prstGeom prst="rect">
            <a:avLst/>
          </a:prstGeom>
        </p:spPr>
      </p:pic>
      <p:sp>
        <p:nvSpPr>
          <p:cNvPr id="6" name="Title 3">
            <a:extLst>
              <a:ext uri="{FF2B5EF4-FFF2-40B4-BE49-F238E27FC236}">
                <a16:creationId xmlns:a16="http://schemas.microsoft.com/office/drawing/2014/main" id="{BC9F749C-2C2E-456A-A744-31731199E12B}"/>
              </a:ext>
            </a:extLst>
          </p:cNvPr>
          <p:cNvSpPr txBox="1">
            <a:spLocks/>
          </p:cNvSpPr>
          <p:nvPr/>
        </p:nvSpPr>
        <p:spPr>
          <a:xfrm>
            <a:off x="259150" y="60927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5b. Forest plot – </a:t>
            </a:r>
            <a:r>
              <a:rPr lang="en-US" sz="2000" dirty="0" err="1"/>
              <a:t>Predialysis</a:t>
            </a:r>
            <a:r>
              <a:rPr lang="en-US" sz="2000" dirty="0"/>
              <a:t> Myoglobin 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C784C3E-3141-4B98-BCB7-5B5B306B0BF1}"/>
              </a:ext>
              <a:ext uri="{147F2762-F138-4A5C-976F-8EAC2B608ADB}">
                <a16:predDERef xmlns:a16="http://schemas.microsoft.com/office/drawing/2014/main" pred="{6D642841-9EAE-41CB-9CF7-AF0C8BE7EF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064" y="3429000"/>
            <a:ext cx="8540814" cy="2545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202247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27070" y="263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6a. Forest plot – Interleukin-6 reduction ratio (%) 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6F4A16D-A1E6-4DF0-BCBE-31BFDC79C3B2}"/>
              </a:ext>
              <a:ext uri="{147F2762-F138-4A5C-976F-8EAC2B608ADB}">
                <a16:predDERef xmlns:a16="http://schemas.microsoft.com/office/drawing/2014/main" pred="{F329F4C8-69FB-4EC7-AAB4-D5E1320E16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145" y="200314"/>
            <a:ext cx="8237378" cy="2349846"/>
          </a:xfrm>
          <a:prstGeom prst="rect">
            <a:avLst/>
          </a:prstGeom>
        </p:spPr>
      </p:pic>
      <p:sp>
        <p:nvSpPr>
          <p:cNvPr id="6" name="Title 3">
            <a:extLst>
              <a:ext uri="{FF2B5EF4-FFF2-40B4-BE49-F238E27FC236}">
                <a16:creationId xmlns:a16="http://schemas.microsoft.com/office/drawing/2014/main" id="{E89277CA-E3E8-4301-A268-4C5CD570D05F}"/>
              </a:ext>
            </a:extLst>
          </p:cNvPr>
          <p:cNvSpPr txBox="1">
            <a:spLocks/>
          </p:cNvSpPr>
          <p:nvPr/>
        </p:nvSpPr>
        <p:spPr>
          <a:xfrm>
            <a:off x="157550" y="60724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6a. Forest plot – Interleukin-6 reduction ratio (%) 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97139A3-62B8-47C2-8FC4-A0B1075FAF44}"/>
              </a:ext>
              <a:ext uri="{147F2762-F138-4A5C-976F-8EAC2B608ADB}">
                <a16:predDERef xmlns:a16="http://schemas.microsoft.com/office/drawing/2014/main" pred="{26F4A16D-A1E6-4DF0-BCBE-31BFDC79C3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949" y="3223606"/>
            <a:ext cx="8433769" cy="2543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6710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27303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1a. Forest plot – Albumin loss - RS.</a:t>
            </a:r>
          </a:p>
        </p:txBody>
      </p:sp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61232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b. Forest plot – Albumin loss - NR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17DB928-8939-4846-BE83-A416177DC992}"/>
              </a:ext>
              <a:ext uri="{147F2762-F138-4A5C-976F-8EAC2B608ADB}">
                <a16:predDERef xmlns:a16="http://schemas.microsoft.com/office/drawing/2014/main" pred="{90E1E5A6-F61C-42A6-AB6F-3D1B032A85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1" y="127174"/>
            <a:ext cx="8242753" cy="275952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BE8A0C-7B37-4D8C-8B07-08E7DA3C99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1" y="3216131"/>
            <a:ext cx="805815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47258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262822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7a. Forest plot – Pre-dialysis Interleukin-6 - RS.</a:t>
            </a:r>
          </a:p>
        </p:txBody>
      </p:sp>
      <p:sp>
        <p:nvSpPr>
          <p:cNvPr id="6" name="Title 3">
            <a:extLst>
              <a:ext uri="{FF2B5EF4-FFF2-40B4-BE49-F238E27FC236}">
                <a16:creationId xmlns:a16="http://schemas.microsoft.com/office/drawing/2014/main" id="{BC9F749C-2C2E-456A-A744-31731199E12B}"/>
              </a:ext>
            </a:extLst>
          </p:cNvPr>
          <p:cNvSpPr txBox="1">
            <a:spLocks/>
          </p:cNvSpPr>
          <p:nvPr/>
        </p:nvSpPr>
        <p:spPr>
          <a:xfrm>
            <a:off x="259150" y="60927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7b. Forest plot – Pre-dialysis Interleukin-6 - NRS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8138DA2-11B3-4D18-8CDB-557FCE8C28B9}"/>
              </a:ext>
              <a:ext uri="{147F2762-F138-4A5C-976F-8EAC2B608ADB}">
                <a16:predDERef xmlns:a16="http://schemas.microsoft.com/office/drawing/2014/main" pred="{50C48B5B-20D5-4651-BD23-62FF027F9C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150" y="0"/>
            <a:ext cx="9510774" cy="270856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0C48B5B-20D5-4651-BD23-62FF027F9C64}"/>
              </a:ext>
              <a:ext uri="{147F2762-F138-4A5C-976F-8EAC2B608ADB}">
                <a16:predDERef xmlns:a16="http://schemas.microsoft.com/office/drawing/2014/main" pred="{4A8F5B6D-35EC-442F-9BC0-7FE964074D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870" y="3446155"/>
            <a:ext cx="9027090" cy="2708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494193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3400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8. Forest plot – Interleukin-6 expression- 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479AB41-17D8-4837-B2EB-1B2DB513CB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6094" y="426810"/>
            <a:ext cx="8903426" cy="2792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954937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27070" y="37051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19. Forest plot – Tumor Necrosis Factor- alpha reduction ratio (%) - RS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C7BC679-EBB1-48B8-B8EA-541A93D1A9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896" y="711200"/>
            <a:ext cx="9191341" cy="2579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67154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3989668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0. Forest plot – Pre-dialysis Tumor Necrosis Factor- alpha - 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14E19B9-7C4C-4592-A4FD-9E02A3C032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1832" y="558274"/>
            <a:ext cx="9339160" cy="2870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988551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3622040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1. Forest plot – Tumor Necrosis Factor- alpha expression- R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4C09130-C591-4171-965D-11764334A7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053" y="520580"/>
            <a:ext cx="9243158" cy="284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962048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262822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2. Forest plot – CRP- RS.</a:t>
            </a:r>
          </a:p>
        </p:txBody>
      </p:sp>
      <p:sp>
        <p:nvSpPr>
          <p:cNvPr id="6" name="Title 3">
            <a:extLst>
              <a:ext uri="{FF2B5EF4-FFF2-40B4-BE49-F238E27FC236}">
                <a16:creationId xmlns:a16="http://schemas.microsoft.com/office/drawing/2014/main" id="{BC9F749C-2C2E-456A-A744-31731199E12B}"/>
              </a:ext>
            </a:extLst>
          </p:cNvPr>
          <p:cNvSpPr txBox="1">
            <a:spLocks/>
          </p:cNvSpPr>
          <p:nvPr/>
        </p:nvSpPr>
        <p:spPr>
          <a:xfrm>
            <a:off x="259150" y="621470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2. Forest plot – CRP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39C057C-30BA-43F6-9C3E-1B017A2B06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933" y="270411"/>
            <a:ext cx="8574214" cy="235781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954906A-E44B-44D1-88F7-83E3CF56AA1C}"/>
              </a:ext>
              <a:ext uri="{147F2762-F138-4A5C-976F-8EAC2B608ADB}">
                <a16:predDERef xmlns:a16="http://schemas.microsoft.com/office/drawing/2014/main" pred="{539C057C-30BA-43F6-9C3E-1B017A2B06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5308" y="3182712"/>
            <a:ext cx="7803784" cy="3092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472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27303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2a. Forest plot – Albumin reduction ratio (%) - RS.</a:t>
            </a:r>
          </a:p>
        </p:txBody>
      </p:sp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612326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2b. Forest plot – Albumin reduction ratio (%) - NR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326650F-230C-44FA-998C-483B9038DE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977" y="3315541"/>
            <a:ext cx="7848600" cy="2743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B86096D-780D-43FB-82F3-25AE3F80D7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247" y="243840"/>
            <a:ext cx="7591425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92728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50671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3a. Forest plot – </a:t>
            </a:r>
            <a:r>
              <a:rPr lang="en-US" sz="2000" dirty="0" err="1"/>
              <a:t>Predialysis</a:t>
            </a:r>
            <a:r>
              <a:rPr lang="en-US" sz="2000" dirty="0"/>
              <a:t> Albumin - RS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F67F8EF-1A00-A54C-997E-BC197EE178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5156" y="149514"/>
            <a:ext cx="8793403" cy="4765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15153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3b. Forest plot – </a:t>
            </a:r>
            <a:r>
              <a:rPr lang="en-US" sz="2000" dirty="0" err="1"/>
              <a:t>Predialysis</a:t>
            </a:r>
            <a:r>
              <a:rPr lang="en-US" sz="2000" dirty="0"/>
              <a:t> Albumin 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B596C73-9E0C-49C9-94CC-B53DB463CD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545" y="197103"/>
            <a:ext cx="8156575" cy="49919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8754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4. </a:t>
            </a:r>
            <a:r>
              <a:rPr lang="en-US" sz="2000" dirty="0">
                <a:latin typeface="Calibri Light (Headings)"/>
              </a:rPr>
              <a:t>Forest plot – Beta-2 macroglobulin </a:t>
            </a:r>
            <a:r>
              <a:rPr lang="en-US" sz="2000" dirty="0"/>
              <a:t>reduction ratio (%)</a:t>
            </a:r>
            <a:r>
              <a:rPr lang="en-US" sz="2000" dirty="0">
                <a:latin typeface="Calibri Light (Headings)"/>
              </a:rPr>
              <a:t> - NR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B596C73-9E0C-49C9-94CC-B53DB463CD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545" y="197103"/>
            <a:ext cx="8156575" cy="49919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44621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51179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5a. Forest plot – </a:t>
            </a:r>
            <a:r>
              <a:rPr lang="en-US" sz="2000" dirty="0">
                <a:latin typeface="Calibri Light (Headings)"/>
              </a:rPr>
              <a:t>Beta-2 macroglobulin removal</a:t>
            </a:r>
            <a:r>
              <a:rPr lang="en-US" sz="2000" dirty="0"/>
              <a:t> 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263BF4-5891-41FB-8EBC-CCB052812256}"/>
              </a:ext>
              <a:ext uri="{147F2762-F138-4A5C-976F-8EAC2B608ADB}">
                <a16:predDERef xmlns:a16="http://schemas.microsoft.com/office/drawing/2014/main" pred="{F145B7E7-B766-43C2-990B-9861D5CA95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615" y="1330960"/>
            <a:ext cx="10649113" cy="3424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798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3">
            <a:extLst>
              <a:ext uri="{FF2B5EF4-FFF2-40B4-BE49-F238E27FC236}">
                <a16:creationId xmlns:a16="http://schemas.microsoft.com/office/drawing/2014/main" id="{785FF1E0-1A5E-E44F-86A1-154B7B4A4149}"/>
              </a:ext>
            </a:extLst>
          </p:cNvPr>
          <p:cNvSpPr txBox="1">
            <a:spLocks/>
          </p:cNvSpPr>
          <p:nvPr/>
        </p:nvSpPr>
        <p:spPr>
          <a:xfrm>
            <a:off x="177870" y="5178389"/>
            <a:ext cx="10515600" cy="58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/>
              <a:t>Figure 5b. Forest plot –</a:t>
            </a:r>
            <a:r>
              <a:rPr lang="en-US" sz="2000" dirty="0">
                <a:latin typeface="Calibri Light (Headings)"/>
              </a:rPr>
              <a:t>Beta-2 macroglobulin removal</a:t>
            </a:r>
            <a:r>
              <a:rPr lang="en-US" sz="2000" dirty="0"/>
              <a:t> - NR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45B7E7-B766-43C2-990B-9861D5CA95FB}"/>
              </a:ext>
              <a:ext uri="{147F2762-F138-4A5C-976F-8EAC2B608ADB}">
                <a16:predDERef xmlns:a16="http://schemas.microsoft.com/office/drawing/2014/main" pred="{A14CBB32-6D26-48EB-8B8C-63DCF8942B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924" y="1503680"/>
            <a:ext cx="10616917" cy="3178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069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61734171-A701-DD48-A4FA-630F174A6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870" y="5117924"/>
            <a:ext cx="10515600" cy="585217"/>
          </a:xfrm>
        </p:spPr>
        <p:txBody>
          <a:bodyPr>
            <a:normAutofit/>
          </a:bodyPr>
          <a:lstStyle/>
          <a:p>
            <a:r>
              <a:rPr lang="en-US" sz="2000" dirty="0"/>
              <a:t>Figure 6. Forest plot – </a:t>
            </a:r>
            <a:r>
              <a:rPr lang="en-US" sz="2000" dirty="0" err="1"/>
              <a:t>Predialysis</a:t>
            </a:r>
            <a:r>
              <a:rPr lang="en-US" sz="2000" dirty="0"/>
              <a:t> </a:t>
            </a:r>
            <a:r>
              <a:rPr lang="en-US" sz="2000" dirty="0">
                <a:latin typeface="Calibri Light (Headings)"/>
              </a:rPr>
              <a:t>Beta-2 macroglobulin</a:t>
            </a:r>
            <a:r>
              <a:rPr lang="en-US" sz="2000" dirty="0"/>
              <a:t> - 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AAC410A-72B5-E84C-B356-FD7562E4D4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7036" y="372216"/>
            <a:ext cx="8470643" cy="4787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3887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433</Words>
  <Application>Microsoft Office PowerPoint</Application>
  <PresentationFormat>Widescreen</PresentationFormat>
  <Paragraphs>34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0" baseType="lpstr">
      <vt:lpstr>Arial</vt:lpstr>
      <vt:lpstr>Calibri</vt:lpstr>
      <vt:lpstr>Calibri Light</vt:lpstr>
      <vt:lpstr>Calibri Light (Headings)</vt:lpstr>
      <vt:lpstr>Office Theme</vt:lpstr>
      <vt:lpstr>Secondary lab outcomes</vt:lpstr>
      <vt:lpstr>Figure 1a. Forest plot – Albumin loss - RS.</vt:lpstr>
      <vt:lpstr>Figure 2a. Forest plot – Albumin reduction ratio (%) - RS.</vt:lpstr>
      <vt:lpstr>Figure 3a. Forest plot – Predialysis Albumin - RS.</vt:lpstr>
      <vt:lpstr>PowerPoint Presentation</vt:lpstr>
      <vt:lpstr>PowerPoint Presentation</vt:lpstr>
      <vt:lpstr>Figure 5a. Forest plot – Beta-2 macroglobulin removal - RS.</vt:lpstr>
      <vt:lpstr>PowerPoint Presentation</vt:lpstr>
      <vt:lpstr>Figure 6. Forest plot – Predialysis Beta-2 macroglobulin - RS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condary lab outcomes</dc:title>
  <dc:creator>maryam kandi</dc:creator>
  <cp:lastModifiedBy>maryam kandi</cp:lastModifiedBy>
  <cp:revision>4</cp:revision>
  <dcterms:created xsi:type="dcterms:W3CDTF">2021-06-06T22:54:41Z</dcterms:created>
  <dcterms:modified xsi:type="dcterms:W3CDTF">2021-06-07T00:54:53Z</dcterms:modified>
</cp:coreProperties>
</file>